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0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2DE63D5-997A-4646-A377-4702673A728D}" styleName="浅色样式 2 - 强调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99" autoAdjust="0"/>
    <p:restoredTop sz="94692"/>
  </p:normalViewPr>
  <p:slideViewPr>
    <p:cSldViewPr snapToGrid="0">
      <p:cViewPr varScale="1">
        <p:scale>
          <a:sx n="104" d="100"/>
          <a:sy n="104" d="100"/>
        </p:scale>
        <p:origin x="205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50CEA4-C18A-FF42-845E-1A918539B620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56084E-5CAD-B149-A9D9-10DCC886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059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1pPr>
    <a:lvl2pPr marL="402153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2pPr>
    <a:lvl3pPr marL="804306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3pPr>
    <a:lvl4pPr marL="1206459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4pPr>
    <a:lvl5pPr marL="1608609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5pPr>
    <a:lvl6pPr marL="2010762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6pPr>
    <a:lvl7pPr marL="2412915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7pPr>
    <a:lvl8pPr marL="2815068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8pPr>
    <a:lvl9pPr marL="3217221" algn="l" defTabSz="804306" rtl="0" eaLnBrk="1" latinLnBrk="0" hangingPunct="1">
      <a:defRPr sz="105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699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315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389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913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657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425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965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886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067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638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733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8C79FC-D047-7041-B9B1-12035D967D54}" type="datetimeFigureOut">
              <a:rPr lang="en-US" smtClean="0"/>
              <a:t>12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E0B03B-E3B9-534C-8988-9DA4DE3E9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230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组合 117">
            <a:extLst>
              <a:ext uri="{FF2B5EF4-FFF2-40B4-BE49-F238E27FC236}">
                <a16:creationId xmlns:a16="http://schemas.microsoft.com/office/drawing/2014/main" id="{9E15EB7F-4121-D004-0502-FD089345076D}"/>
              </a:ext>
            </a:extLst>
          </p:cNvPr>
          <p:cNvGrpSpPr/>
          <p:nvPr/>
        </p:nvGrpSpPr>
        <p:grpSpPr>
          <a:xfrm>
            <a:off x="70061" y="166010"/>
            <a:ext cx="9765878" cy="5571497"/>
            <a:chOff x="143912" y="-1265"/>
            <a:chExt cx="3469422" cy="200610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589C290-FC97-48B9-8B0A-71D8B45813CF}"/>
                </a:ext>
              </a:extLst>
            </p:cNvPr>
            <p:cNvSpPr txBox="1"/>
            <p:nvPr/>
          </p:nvSpPr>
          <p:spPr>
            <a:xfrm>
              <a:off x="1573864" y="-1265"/>
              <a:ext cx="829018" cy="997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ervical sections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=2085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B8510AD-CD8F-270D-7684-1E82C9579073}"/>
                </a:ext>
              </a:extLst>
            </p:cNvPr>
            <p:cNvSpPr txBox="1"/>
            <p:nvPr/>
          </p:nvSpPr>
          <p:spPr>
            <a:xfrm>
              <a:off x="523325" y="307739"/>
              <a:ext cx="494331" cy="997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2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C(n=131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FE77162-0809-520A-734D-D0799FC96D9D}"/>
                </a:ext>
              </a:extLst>
            </p:cNvPr>
            <p:cNvSpPr txBox="1"/>
            <p:nvPr/>
          </p:nvSpPr>
          <p:spPr>
            <a:xfrm>
              <a:off x="1647059" y="293757"/>
              <a:ext cx="607976" cy="997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SIL(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=1689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1ED44F1-609C-07E2-02C3-5D8B2E9A1991}"/>
                </a:ext>
              </a:extLst>
            </p:cNvPr>
            <p:cNvSpPr txBox="1"/>
            <p:nvPr/>
          </p:nvSpPr>
          <p:spPr>
            <a:xfrm>
              <a:off x="2905339" y="296363"/>
              <a:ext cx="425406" cy="997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CC(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=265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E99082A-337D-BD14-C4FE-263953C80A6B}"/>
                </a:ext>
              </a:extLst>
            </p:cNvPr>
            <p:cNvSpPr txBox="1"/>
            <p:nvPr/>
          </p:nvSpPr>
          <p:spPr>
            <a:xfrm>
              <a:off x="143912" y="534690"/>
              <a:ext cx="539299" cy="232722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xcluded :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. Chronic illness, n-=57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. Incomplete medical record, n=1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DD6EE30-ADCF-86DD-B1F7-0A795600BEB0}"/>
                </a:ext>
              </a:extLst>
            </p:cNvPr>
            <p:cNvSpPr txBox="1"/>
            <p:nvPr/>
          </p:nvSpPr>
          <p:spPr>
            <a:xfrm>
              <a:off x="1045346" y="518064"/>
              <a:ext cx="819689" cy="4321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 algn="ctr">
                <a:defRPr sz="300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l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xcluded :</a:t>
              </a:r>
            </a:p>
            <a:p>
              <a:pPr algn="l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. Chronic illness, n-=239</a:t>
              </a:r>
            </a:p>
            <a:p>
              <a:pPr algn="l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. No pre-operative HPV test, n=90</a:t>
              </a:r>
            </a:p>
            <a:p>
              <a:pPr algn="l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. Untyped or low risk HPV, n=61</a:t>
              </a:r>
            </a:p>
            <a:p>
              <a:pPr algn="l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. No pre-operative blood test, n=87</a:t>
              </a:r>
            </a:p>
            <a:p>
              <a:pPr algn="l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. Inadequate paraffin wax embedded tissue, n=12</a:t>
              </a:r>
            </a:p>
            <a:p>
              <a:pPr algn="l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6. Incomplete medical record, n=3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0A2F210-18A2-F587-57F2-ACBDDCB50F32}"/>
                </a:ext>
              </a:extLst>
            </p:cNvPr>
            <p:cNvSpPr txBox="1"/>
            <p:nvPr/>
          </p:nvSpPr>
          <p:spPr>
            <a:xfrm>
              <a:off x="2197646" y="514447"/>
              <a:ext cx="843000" cy="44882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xcluded :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. Chronic illness, n-=86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. No pre-operative HPV test , n=61</a:t>
              </a:r>
            </a:p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3. Untyped or low risk HPV, n=2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4. Pre-operative chemotherapy, n=48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. Inadequate paraffin wax embedded tissue, n=12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6. Incomplete medical record, n=4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3BEC13C7-B0C3-F5D8-22E3-F2709CB8A59F}"/>
                </a:ext>
              </a:extLst>
            </p:cNvPr>
            <p:cNvCxnSpPr>
              <a:cxnSpLocks/>
            </p:cNvCxnSpPr>
            <p:nvPr/>
          </p:nvCxnSpPr>
          <p:spPr>
            <a:xfrm>
              <a:off x="761979" y="193871"/>
              <a:ext cx="2376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BC8F6643-A40D-3320-4F00-5783505A6933}"/>
                </a:ext>
              </a:extLst>
            </p:cNvPr>
            <p:cNvCxnSpPr>
              <a:cxnSpLocks/>
            </p:cNvCxnSpPr>
            <p:nvPr/>
          </p:nvCxnSpPr>
          <p:spPr>
            <a:xfrm>
              <a:off x="763900" y="193871"/>
              <a:ext cx="0" cy="111561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D4EE4824-EF6A-581F-5BD3-614410A1E9F3}"/>
                </a:ext>
              </a:extLst>
            </p:cNvPr>
            <p:cNvCxnSpPr>
              <a:cxnSpLocks/>
            </p:cNvCxnSpPr>
            <p:nvPr/>
          </p:nvCxnSpPr>
          <p:spPr>
            <a:xfrm>
              <a:off x="1956274" y="96031"/>
              <a:ext cx="0" cy="19568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41C7AFD6-B823-F967-A215-4D0DFF28470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36996" y="193871"/>
              <a:ext cx="0" cy="97616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E6290776-DFF0-F971-B04A-5000722C7E0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56274" y="400133"/>
              <a:ext cx="0" cy="697254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3139D347-FA6B-A8EF-3E4E-43A4479BAD78}"/>
                </a:ext>
              </a:extLst>
            </p:cNvPr>
            <p:cNvCxnSpPr>
              <a:cxnSpLocks/>
            </p:cNvCxnSpPr>
            <p:nvPr/>
          </p:nvCxnSpPr>
          <p:spPr>
            <a:xfrm>
              <a:off x="765991" y="400133"/>
              <a:ext cx="0" cy="697254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C5BEC07A-8A32-14DE-1FE1-E41B1F77A66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36996" y="395943"/>
              <a:ext cx="0" cy="697377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E8083DD8-7110-0839-EF8E-68983C4CFD0C}"/>
                </a:ext>
              </a:extLst>
            </p:cNvPr>
            <p:cNvCxnSpPr>
              <a:cxnSpLocks/>
            </p:cNvCxnSpPr>
            <p:nvPr/>
          </p:nvCxnSpPr>
          <p:spPr>
            <a:xfrm>
              <a:off x="1870254" y="696634"/>
              <a:ext cx="90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141F3927-C79C-61A9-8941-E146EE743D1D}"/>
                </a:ext>
              </a:extLst>
            </p:cNvPr>
            <p:cNvCxnSpPr>
              <a:cxnSpLocks/>
            </p:cNvCxnSpPr>
            <p:nvPr/>
          </p:nvCxnSpPr>
          <p:spPr>
            <a:xfrm>
              <a:off x="3040646" y="696609"/>
              <a:ext cx="90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2764014-FF91-7D76-84D4-DBE54A278E3A}"/>
                </a:ext>
              </a:extLst>
            </p:cNvPr>
            <p:cNvSpPr txBox="1"/>
            <p:nvPr/>
          </p:nvSpPr>
          <p:spPr>
            <a:xfrm>
              <a:off x="402715" y="1099916"/>
              <a:ext cx="758797" cy="886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ligible samples(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=62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734CC1CD-6906-EECC-CC3F-77A173331114}"/>
                </a:ext>
              </a:extLst>
            </p:cNvPr>
            <p:cNvGrpSpPr/>
            <p:nvPr/>
          </p:nvGrpSpPr>
          <p:grpSpPr>
            <a:xfrm>
              <a:off x="210361" y="1474271"/>
              <a:ext cx="1126999" cy="146171"/>
              <a:chOff x="2337207" y="5050085"/>
              <a:chExt cx="2179562" cy="219555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36C2F01-9651-9A39-A7FB-BCA1DC05003F}"/>
                  </a:ext>
                </a:extLst>
              </p:cNvPr>
              <p:cNvSpPr txBox="1"/>
              <p:nvPr/>
            </p:nvSpPr>
            <p:spPr>
              <a:xfrm>
                <a:off x="2337207" y="5050085"/>
                <a:ext cx="952479" cy="216394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ctr">
                <a:spAutoFit/>
              </a:bodyPr>
              <a:lstStyle>
                <a:defPPr>
                  <a:defRPr lang="en-US"/>
                </a:defPPr>
                <a:lvl1pPr>
                  <a:defRPr sz="10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HR-HPV positive</a:t>
                </a:r>
              </a:p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n=3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FC7FA13-6673-BB5B-3BE1-23BA824B2AE1}"/>
                  </a:ext>
                </a:extLst>
              </p:cNvPr>
              <p:cNvSpPr txBox="1"/>
              <p:nvPr/>
            </p:nvSpPr>
            <p:spPr>
              <a:xfrm>
                <a:off x="3375583" y="5053246"/>
                <a:ext cx="1141186" cy="216394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 anchor="ctr">
                <a:spAutoFit/>
              </a:bodyPr>
              <a:lstStyle>
                <a:defPPr>
                  <a:defRPr lang="en-US"/>
                </a:defPPr>
                <a:lvl1pPr>
                  <a:defRPr sz="10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HR-HPV negative</a:t>
                </a:r>
              </a:p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NC, n=59</a:t>
                </a:r>
              </a:p>
            </p:txBody>
          </p:sp>
        </p:grp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33CCF660-6FFA-C810-A6F0-8574831CB274}"/>
                </a:ext>
              </a:extLst>
            </p:cNvPr>
            <p:cNvCxnSpPr>
              <a:cxnSpLocks/>
            </p:cNvCxnSpPr>
            <p:nvPr/>
          </p:nvCxnSpPr>
          <p:spPr>
            <a:xfrm>
              <a:off x="462920" y="1338204"/>
              <a:ext cx="60308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31C46F88-E7C5-2580-508F-33C08B5F8926}"/>
                </a:ext>
              </a:extLst>
            </p:cNvPr>
            <p:cNvCxnSpPr/>
            <p:nvPr/>
          </p:nvCxnSpPr>
          <p:spPr>
            <a:xfrm>
              <a:off x="767785" y="1194401"/>
              <a:ext cx="0" cy="143803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29D53FB7-855C-E864-87CA-16CCD9A063C6}"/>
                </a:ext>
              </a:extLst>
            </p:cNvPr>
            <p:cNvCxnSpPr/>
            <p:nvPr/>
          </p:nvCxnSpPr>
          <p:spPr>
            <a:xfrm>
              <a:off x="462920" y="1335934"/>
              <a:ext cx="0" cy="143803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D123E07A-6552-6A82-B9A4-A8B56470A4CD}"/>
                </a:ext>
              </a:extLst>
            </p:cNvPr>
            <p:cNvCxnSpPr/>
            <p:nvPr/>
          </p:nvCxnSpPr>
          <p:spPr>
            <a:xfrm>
              <a:off x="1066008" y="1335934"/>
              <a:ext cx="0" cy="143803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DCDCF12-CEE0-6EEE-B282-DA52912E4203}"/>
                </a:ext>
              </a:extLst>
            </p:cNvPr>
            <p:cNvSpPr txBox="1"/>
            <p:nvPr/>
          </p:nvSpPr>
          <p:spPr>
            <a:xfrm>
              <a:off x="1664456" y="1095477"/>
              <a:ext cx="593369" cy="886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ligible samples(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=52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5B1A6A39-61E0-16DA-52D8-A55C7DA78D9F}"/>
                </a:ext>
              </a:extLst>
            </p:cNvPr>
            <p:cNvSpPr txBox="1"/>
            <p:nvPr/>
          </p:nvSpPr>
          <p:spPr>
            <a:xfrm>
              <a:off x="1409348" y="1479737"/>
              <a:ext cx="480977" cy="144066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HR-HPV positive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HSIL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, n=47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0A01CB5-B3D2-8CEB-ED52-5E0482C13FF8}"/>
                </a:ext>
              </a:extLst>
            </p:cNvPr>
            <p:cNvSpPr txBox="1"/>
            <p:nvPr/>
          </p:nvSpPr>
          <p:spPr>
            <a:xfrm>
              <a:off x="2007925" y="1473466"/>
              <a:ext cx="466590" cy="144066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HR-HPV negative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HSIL, n=5</a:t>
              </a: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60B2359C-597E-165F-9158-8E11E63882F5}"/>
                </a:ext>
              </a:extLst>
            </p:cNvPr>
            <p:cNvCxnSpPr>
              <a:cxnSpLocks/>
            </p:cNvCxnSpPr>
            <p:nvPr/>
          </p:nvCxnSpPr>
          <p:spPr>
            <a:xfrm>
              <a:off x="1664455" y="1333611"/>
              <a:ext cx="59337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7A9A2BD2-233F-E652-9F73-9BBD19D9FAA7}"/>
                </a:ext>
              </a:extLst>
            </p:cNvPr>
            <p:cNvCxnSpPr/>
            <p:nvPr/>
          </p:nvCxnSpPr>
          <p:spPr>
            <a:xfrm>
              <a:off x="1960254" y="1188142"/>
              <a:ext cx="0" cy="143804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24D1DB37-FB04-9B39-3974-AC7FE190420B}"/>
                </a:ext>
              </a:extLst>
            </p:cNvPr>
            <p:cNvCxnSpPr>
              <a:cxnSpLocks/>
            </p:cNvCxnSpPr>
            <p:nvPr/>
          </p:nvCxnSpPr>
          <p:spPr>
            <a:xfrm>
              <a:off x="1664455" y="1331946"/>
              <a:ext cx="0" cy="143803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AC0E3D69-8FC4-2C30-03E7-2258C5214AEF}"/>
                </a:ext>
              </a:extLst>
            </p:cNvPr>
            <p:cNvCxnSpPr/>
            <p:nvPr/>
          </p:nvCxnSpPr>
          <p:spPr>
            <a:xfrm>
              <a:off x="2840927" y="1330464"/>
              <a:ext cx="0" cy="143803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EDF9CDD6-DCE8-1ABD-6A91-6C63C85ED221}"/>
                </a:ext>
              </a:extLst>
            </p:cNvPr>
            <p:cNvSpPr txBox="1"/>
            <p:nvPr/>
          </p:nvSpPr>
          <p:spPr>
            <a:xfrm>
              <a:off x="2832791" y="1098252"/>
              <a:ext cx="593369" cy="886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ligible samples(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=52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CEF52A46-C44C-0368-6881-34362AAC82D9}"/>
                </a:ext>
              </a:extLst>
            </p:cNvPr>
            <p:cNvGrpSpPr/>
            <p:nvPr/>
          </p:nvGrpSpPr>
          <p:grpSpPr>
            <a:xfrm>
              <a:off x="2572620" y="1477441"/>
              <a:ext cx="1040714" cy="146374"/>
              <a:chOff x="1680858" y="4941865"/>
              <a:chExt cx="1546052" cy="219866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58228BFC-5B05-93D7-87E3-12EEC7FEC419}"/>
                  </a:ext>
                </a:extLst>
              </p:cNvPr>
              <p:cNvSpPr txBox="1"/>
              <p:nvPr/>
            </p:nvSpPr>
            <p:spPr>
              <a:xfrm>
                <a:off x="1680858" y="4941865"/>
                <a:ext cx="695284" cy="216398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 anchor="ctr">
                <a:spAutoFit/>
              </a:bodyPr>
              <a:lstStyle>
                <a:defPPr>
                  <a:defRPr lang="en-US"/>
                </a:defPPr>
                <a:lvl1pPr>
                  <a:defRPr sz="10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HR-HPV positive</a:t>
                </a:r>
              </a:p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SCC, n=42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DC207026-9BDA-EB4A-0712-79533EFA21C6}"/>
                  </a:ext>
                </a:extLst>
              </p:cNvPr>
              <p:cNvSpPr txBox="1"/>
              <p:nvPr/>
            </p:nvSpPr>
            <p:spPr>
              <a:xfrm>
                <a:off x="2508105" y="4945333"/>
                <a:ext cx="718805" cy="216398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 anchor="ctr">
                <a:spAutoFit/>
              </a:bodyPr>
              <a:lstStyle>
                <a:defPPr>
                  <a:defRPr lang="en-US"/>
                </a:defPPr>
                <a:lvl1pPr>
                  <a:defRPr sz="10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HR-HPV negative</a:t>
                </a:r>
              </a:p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SCC, n=10</a:t>
                </a:r>
              </a:p>
            </p:txBody>
          </p:sp>
        </p:grp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F025B641-E3A7-480A-3DCD-301251C312F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40927" y="1330464"/>
              <a:ext cx="612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8814456B-13C7-3CA4-66D0-2376B36494F9}"/>
                </a:ext>
              </a:extLst>
            </p:cNvPr>
            <p:cNvCxnSpPr/>
            <p:nvPr/>
          </p:nvCxnSpPr>
          <p:spPr>
            <a:xfrm>
              <a:off x="3142172" y="1186661"/>
              <a:ext cx="0" cy="143803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5BB9794A-D91B-75CF-C747-F5FB749DE43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5035" y="1331946"/>
              <a:ext cx="0" cy="143883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909AD3B3-D90B-05F9-965D-D8AAD844289F}"/>
                </a:ext>
              </a:extLst>
            </p:cNvPr>
            <p:cNvCxnSpPr/>
            <p:nvPr/>
          </p:nvCxnSpPr>
          <p:spPr>
            <a:xfrm>
              <a:off x="3447303" y="1327283"/>
              <a:ext cx="0" cy="14400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E344215A-D1A8-071F-6306-1782BE4C4F8C}"/>
                </a:ext>
              </a:extLst>
            </p:cNvPr>
            <p:cNvCxnSpPr>
              <a:cxnSpLocks/>
            </p:cNvCxnSpPr>
            <p:nvPr/>
          </p:nvCxnSpPr>
          <p:spPr>
            <a:xfrm>
              <a:off x="1056809" y="1772336"/>
              <a:ext cx="240203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83C270A0-7EA0-88C8-6EDD-73C70B80888D}"/>
                </a:ext>
              </a:extLst>
            </p:cNvPr>
            <p:cNvSpPr txBox="1"/>
            <p:nvPr/>
          </p:nvSpPr>
          <p:spPr>
            <a:xfrm>
              <a:off x="1806731" y="1860778"/>
              <a:ext cx="896609" cy="14406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Study populations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=163</a:t>
              </a:r>
            </a:p>
          </p:txBody>
        </p:sp>
        <p:cxnSp>
          <p:nvCxnSpPr>
            <p:cNvPr id="50" name="Straight Connector 35">
              <a:extLst>
                <a:ext uri="{FF2B5EF4-FFF2-40B4-BE49-F238E27FC236}">
                  <a16:creationId xmlns:a16="http://schemas.microsoft.com/office/drawing/2014/main" id="{1D581D9E-5FAE-FA5E-EC9E-7CC7D5CC2833}"/>
                </a:ext>
              </a:extLst>
            </p:cNvPr>
            <p:cNvCxnSpPr>
              <a:cxnSpLocks/>
            </p:cNvCxnSpPr>
            <p:nvPr/>
          </p:nvCxnSpPr>
          <p:spPr>
            <a:xfrm>
              <a:off x="683214" y="643066"/>
              <a:ext cx="90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99" name="Straight Connector 58">
              <a:extLst>
                <a:ext uri="{FF2B5EF4-FFF2-40B4-BE49-F238E27FC236}">
                  <a16:creationId xmlns:a16="http://schemas.microsoft.com/office/drawing/2014/main" id="{1DEF709B-45D3-CBDE-7563-904BDFF7A94E}"/>
                </a:ext>
              </a:extLst>
            </p:cNvPr>
            <p:cNvCxnSpPr/>
            <p:nvPr/>
          </p:nvCxnSpPr>
          <p:spPr>
            <a:xfrm>
              <a:off x="1058453" y="1625334"/>
              <a:ext cx="0" cy="143804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100" name="Straight Connector 58">
              <a:extLst>
                <a:ext uri="{FF2B5EF4-FFF2-40B4-BE49-F238E27FC236}">
                  <a16:creationId xmlns:a16="http://schemas.microsoft.com/office/drawing/2014/main" id="{F2E25013-A4E1-9F06-3328-CE0D47140273}"/>
                </a:ext>
              </a:extLst>
            </p:cNvPr>
            <p:cNvCxnSpPr/>
            <p:nvPr/>
          </p:nvCxnSpPr>
          <p:spPr>
            <a:xfrm>
              <a:off x="1664455" y="1623803"/>
              <a:ext cx="0" cy="143804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101" name="Straight Connector 58">
              <a:extLst>
                <a:ext uri="{FF2B5EF4-FFF2-40B4-BE49-F238E27FC236}">
                  <a16:creationId xmlns:a16="http://schemas.microsoft.com/office/drawing/2014/main" id="{1CB933C9-5CF8-D262-3660-656E9BB89FE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5035" y="1619633"/>
              <a:ext cx="0" cy="243044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108" name="Straight Connector 58">
              <a:extLst>
                <a:ext uri="{FF2B5EF4-FFF2-40B4-BE49-F238E27FC236}">
                  <a16:creationId xmlns:a16="http://schemas.microsoft.com/office/drawing/2014/main" id="{5FB05685-BC6C-41A0-15A4-EFF1A31028FB}"/>
                </a:ext>
              </a:extLst>
            </p:cNvPr>
            <p:cNvCxnSpPr/>
            <p:nvPr/>
          </p:nvCxnSpPr>
          <p:spPr>
            <a:xfrm>
              <a:off x="2840927" y="1623803"/>
              <a:ext cx="0" cy="143804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  <p:cxnSp>
          <p:nvCxnSpPr>
            <p:cNvPr id="109" name="Straight Connector 58">
              <a:extLst>
                <a:ext uri="{FF2B5EF4-FFF2-40B4-BE49-F238E27FC236}">
                  <a16:creationId xmlns:a16="http://schemas.microsoft.com/office/drawing/2014/main" id="{49DAE012-050C-2551-6C15-C5EABBC5677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52927" y="1628336"/>
              <a:ext cx="0" cy="14400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</p:cxn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983C2AD2-FAA3-BA3F-FF1D-EA3D8A07D3AD}"/>
              </a:ext>
            </a:extLst>
          </p:cNvPr>
          <p:cNvSpPr txBox="1"/>
          <p:nvPr/>
        </p:nvSpPr>
        <p:spPr>
          <a:xfrm>
            <a:off x="38608" y="5774455"/>
            <a:ext cx="972727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dditional files 1 .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A flow diagram to summarize the screening process of the study subjects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NC no cervical epithelial lesions, HSIL high-grade squamous intraepithelial lesion, SCC squamous cell carcinoma of the cervix.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2127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332</TotalTime>
  <Words>269</Words>
  <Application>Microsoft Office PowerPoint</Application>
  <PresentationFormat>A4 纸张(210x297 毫米)</PresentationFormat>
  <Paragraphs>3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 Zeng</dc:creator>
  <cp:lastModifiedBy>闵 少菊</cp:lastModifiedBy>
  <cp:revision>150</cp:revision>
  <dcterms:created xsi:type="dcterms:W3CDTF">2023-05-11T11:35:51Z</dcterms:created>
  <dcterms:modified xsi:type="dcterms:W3CDTF">2025-12-20T08:06:01Z</dcterms:modified>
</cp:coreProperties>
</file>